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124" d="100"/>
          <a:sy n="124" d="100"/>
        </p:scale>
        <p:origin x="1824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06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5011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7762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5860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759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3359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2222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557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8569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055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6120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8982F-1B63-D34F-815C-B16AA171B098}" type="datetimeFigureOut">
              <a:rPr kumimoji="1" lang="ja-JP" altLang="en-US" smtClean="0"/>
              <a:t>2021/8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242D0A-C360-644F-9296-5F9F3A2D72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037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Relationship Id="rId9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図形グループ 65"/>
          <p:cNvGrpSpPr/>
          <p:nvPr/>
        </p:nvGrpSpPr>
        <p:grpSpPr>
          <a:xfrm>
            <a:off x="6663600" y="50781"/>
            <a:ext cx="2141388" cy="3232094"/>
            <a:chOff x="6576680" y="50781"/>
            <a:chExt cx="2141388" cy="3232094"/>
          </a:xfrm>
        </p:grpSpPr>
        <p:grpSp>
          <p:nvGrpSpPr>
            <p:cNvPr id="58" name="図形グループ 57"/>
            <p:cNvGrpSpPr/>
            <p:nvPr/>
          </p:nvGrpSpPr>
          <p:grpSpPr>
            <a:xfrm>
              <a:off x="6576680" y="50781"/>
              <a:ext cx="2141388" cy="3232094"/>
              <a:chOff x="265686" y="114290"/>
              <a:chExt cx="2141388" cy="3232094"/>
            </a:xfrm>
          </p:grpSpPr>
          <p:sp>
            <p:nvSpPr>
              <p:cNvPr id="60" name="テキスト ボックス 59"/>
              <p:cNvSpPr txBox="1"/>
              <p:nvPr/>
            </p:nvSpPr>
            <p:spPr>
              <a:xfrm>
                <a:off x="269819" y="114290"/>
                <a:ext cx="2137255" cy="5770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4) Combinations of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penicillin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, 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incl. beta-lactamase inhibitors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(J01CR)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 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265686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4.0 (2.0–8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04 (0.93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15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62" name="図形グループ 61"/>
              <p:cNvGrpSpPr/>
              <p:nvPr/>
            </p:nvGrpSpPr>
            <p:grpSpPr>
              <a:xfrm>
                <a:off x="287518" y="1823677"/>
                <a:ext cx="1204221" cy="1522707"/>
                <a:chOff x="325683" y="1823677"/>
                <a:chExt cx="1204221" cy="1522707"/>
              </a:xfrm>
            </p:grpSpPr>
            <p:sp>
              <p:nvSpPr>
                <p:cNvPr id="63" name="テキスト ボックス 62"/>
                <p:cNvSpPr txBox="1"/>
                <p:nvPr/>
              </p:nvSpPr>
              <p:spPr>
                <a:xfrm rot="16200000">
                  <a:off x="249851" y="1899509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64" name="テキスト ボックス 63"/>
                <p:cNvSpPr txBox="1"/>
                <p:nvPr/>
              </p:nvSpPr>
              <p:spPr>
                <a:xfrm>
                  <a:off x="951851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65" name="図 6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803480" y="963876"/>
              <a:ext cx="1440000" cy="2160000"/>
            </a:xfrm>
            <a:prstGeom prst="rect">
              <a:avLst/>
            </a:prstGeom>
          </p:spPr>
        </p:pic>
      </p:grpSp>
      <p:grpSp>
        <p:nvGrpSpPr>
          <p:cNvPr id="83" name="図形グループ 82"/>
          <p:cNvGrpSpPr/>
          <p:nvPr/>
        </p:nvGrpSpPr>
        <p:grpSpPr>
          <a:xfrm>
            <a:off x="185141" y="3529243"/>
            <a:ext cx="2077199" cy="3232094"/>
            <a:chOff x="185141" y="3529243"/>
            <a:chExt cx="2077199" cy="3232094"/>
          </a:xfrm>
        </p:grpSpPr>
        <p:grpSp>
          <p:nvGrpSpPr>
            <p:cNvPr id="67" name="図形グループ 66"/>
            <p:cNvGrpSpPr/>
            <p:nvPr/>
          </p:nvGrpSpPr>
          <p:grpSpPr>
            <a:xfrm>
              <a:off x="185141" y="3529243"/>
              <a:ext cx="2077199" cy="3232094"/>
              <a:chOff x="269819" y="114290"/>
              <a:chExt cx="2077199" cy="3232094"/>
            </a:xfrm>
          </p:grpSpPr>
          <p:sp>
            <p:nvSpPr>
              <p:cNvPr id="68" name="テキスト ボックス 67"/>
              <p:cNvSpPr txBox="1"/>
              <p:nvPr/>
            </p:nvSpPr>
            <p:spPr>
              <a:xfrm>
                <a:off x="269819" y="114290"/>
                <a:ext cx="2017659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5) Second-generation </a:t>
                </a:r>
              </a:p>
              <a:p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cephalosporin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J01DC) (</a:t>
                </a:r>
                <a:r>
                  <a:rPr kumimoji="1" lang="en-US" altLang="ja-JP" sz="1050" b="1" dirty="0" err="1">
                    <a:latin typeface="Helvetica"/>
                    <a:ea typeface="メイリオ"/>
                    <a:cs typeface="Helvetica"/>
                  </a:rPr>
                  <a:t>po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69" name="テキスト ボックス 68"/>
              <p:cNvSpPr txBox="1"/>
              <p:nvPr/>
            </p:nvSpPr>
            <p:spPr>
              <a:xfrm>
                <a:off x="269819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4.5 (1.5–9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79 (0.83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3.20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70" name="図形グループ 69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72" name="テキスト ボックス 71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73" name="テキスト ボックス 72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74" name="図 7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0400" y="44424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11" name="図形グループ 10"/>
          <p:cNvGrpSpPr/>
          <p:nvPr/>
        </p:nvGrpSpPr>
        <p:grpSpPr>
          <a:xfrm>
            <a:off x="185141" y="50781"/>
            <a:ext cx="2141388" cy="3232094"/>
            <a:chOff x="185141" y="50781"/>
            <a:chExt cx="2141388" cy="3232094"/>
          </a:xfrm>
        </p:grpSpPr>
        <p:grpSp>
          <p:nvGrpSpPr>
            <p:cNvPr id="10" name="図形グループ 9"/>
            <p:cNvGrpSpPr/>
            <p:nvPr/>
          </p:nvGrpSpPr>
          <p:grpSpPr>
            <a:xfrm>
              <a:off x="185141" y="50781"/>
              <a:ext cx="2141388" cy="3232094"/>
              <a:chOff x="269819" y="114290"/>
              <a:chExt cx="2141388" cy="3232094"/>
            </a:xfrm>
          </p:grpSpPr>
          <p:sp>
            <p:nvSpPr>
              <p:cNvPr id="4" name="テキスト ボックス 3"/>
              <p:cNvSpPr txBox="1"/>
              <p:nvPr/>
            </p:nvSpPr>
            <p:spPr>
              <a:xfrm>
                <a:off x="269819" y="114290"/>
                <a:ext cx="95793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Total (</a:t>
                </a:r>
                <a:r>
                  <a:rPr kumimoji="1" lang="en-US" altLang="ja-JP" sz="1050" b="1" dirty="0" err="1">
                    <a:latin typeface="Helvetica"/>
                    <a:ea typeface="メイリオ"/>
                    <a:cs typeface="Helvetica"/>
                  </a:rPr>
                  <a:t>po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5" name="テキスト ボックス 4"/>
              <p:cNvSpPr txBox="1"/>
              <p:nvPr/>
            </p:nvSpPr>
            <p:spPr>
              <a:xfrm>
                <a:off x="269819" y="658053"/>
                <a:ext cx="21413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5.0 (2.0–11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87 (0.82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0.92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9" name="図形グループ 8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7" name="テキスト ボックス 6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8" name="テキスト ボックス 7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3" name="図 2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0400" y="9648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13" name="図形グループ 12"/>
          <p:cNvGrpSpPr/>
          <p:nvPr/>
        </p:nvGrpSpPr>
        <p:grpSpPr>
          <a:xfrm>
            <a:off x="2344879" y="50781"/>
            <a:ext cx="2077199" cy="3232094"/>
            <a:chOff x="2344879" y="50781"/>
            <a:chExt cx="2077199" cy="3232094"/>
          </a:xfrm>
        </p:grpSpPr>
        <p:grpSp>
          <p:nvGrpSpPr>
            <p:cNvPr id="32" name="図形グループ 31"/>
            <p:cNvGrpSpPr/>
            <p:nvPr/>
          </p:nvGrpSpPr>
          <p:grpSpPr>
            <a:xfrm>
              <a:off x="2344879" y="50781"/>
              <a:ext cx="2077199" cy="3232094"/>
              <a:chOff x="267001" y="114290"/>
              <a:chExt cx="2077199" cy="3232094"/>
            </a:xfrm>
          </p:grpSpPr>
          <p:sp>
            <p:nvSpPr>
              <p:cNvPr id="33" name="テキスト ボックス 32"/>
              <p:cNvSpPr txBox="1"/>
              <p:nvPr/>
            </p:nvSpPr>
            <p:spPr>
              <a:xfrm>
                <a:off x="269819" y="114290"/>
                <a:ext cx="89290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2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Total 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267001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5.0 (2.0–9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03 (0.99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06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35" name="図形グループ 34"/>
              <p:cNvGrpSpPr/>
              <p:nvPr/>
            </p:nvGrpSpPr>
            <p:grpSpPr>
              <a:xfrm>
                <a:off x="287554" y="1823677"/>
                <a:ext cx="1204221" cy="1522707"/>
                <a:chOff x="325719" y="1823677"/>
                <a:chExt cx="1204221" cy="1522707"/>
              </a:xfrm>
            </p:grpSpPr>
            <p:sp>
              <p:nvSpPr>
                <p:cNvPr id="37" name="テキスト ボックス 36"/>
                <p:cNvSpPr txBox="1"/>
                <p:nvPr/>
              </p:nvSpPr>
              <p:spPr>
                <a:xfrm rot="16200000">
                  <a:off x="249887" y="1899509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38" name="テキスト ボックス 37"/>
                <p:cNvSpPr txBox="1"/>
                <p:nvPr/>
              </p:nvSpPr>
              <p:spPr>
                <a:xfrm>
                  <a:off x="951887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12" name="図 11"/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70400" y="9648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15" name="図形グループ 14"/>
          <p:cNvGrpSpPr/>
          <p:nvPr/>
        </p:nvGrpSpPr>
        <p:grpSpPr>
          <a:xfrm>
            <a:off x="4503600" y="50781"/>
            <a:ext cx="2141388" cy="3232094"/>
            <a:chOff x="4503600" y="50781"/>
            <a:chExt cx="2141388" cy="3232094"/>
          </a:xfrm>
        </p:grpSpPr>
        <p:grpSp>
          <p:nvGrpSpPr>
            <p:cNvPr id="41" name="図形グループ 40"/>
            <p:cNvGrpSpPr/>
            <p:nvPr/>
          </p:nvGrpSpPr>
          <p:grpSpPr>
            <a:xfrm>
              <a:off x="4503600" y="50781"/>
              <a:ext cx="2141388" cy="3232094"/>
              <a:chOff x="265686" y="114290"/>
              <a:chExt cx="2141388" cy="3232094"/>
            </a:xfrm>
          </p:grpSpPr>
          <p:sp>
            <p:nvSpPr>
              <p:cNvPr id="42" name="テキスト ボックス 41"/>
              <p:cNvSpPr txBox="1"/>
              <p:nvPr/>
            </p:nvSpPr>
            <p:spPr>
              <a:xfrm>
                <a:off x="269819" y="114290"/>
                <a:ext cx="2137255" cy="5770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3) Combinations of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penicillin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, 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incl. beta-lactamase inhibitors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(J01CR)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 (</a:t>
                </a:r>
                <a:r>
                  <a:rPr kumimoji="1" lang="en-US" altLang="ja-JP" sz="1050" b="1" dirty="0" err="1">
                    <a:latin typeface="Helvetica"/>
                    <a:ea typeface="メイリオ"/>
                    <a:cs typeface="Helvetica"/>
                  </a:rPr>
                  <a:t>po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43" name="テキスト ボックス 42"/>
              <p:cNvSpPr txBox="1"/>
              <p:nvPr/>
            </p:nvSpPr>
            <p:spPr>
              <a:xfrm>
                <a:off x="265686" y="658053"/>
                <a:ext cx="21413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3.0 (2.5–11.5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65 (0.34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06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44" name="図形グループ 43"/>
              <p:cNvGrpSpPr/>
              <p:nvPr/>
            </p:nvGrpSpPr>
            <p:grpSpPr>
              <a:xfrm>
                <a:off x="287518" y="1823677"/>
                <a:ext cx="1204221" cy="1522707"/>
                <a:chOff x="325683" y="1823677"/>
                <a:chExt cx="1204221" cy="1522707"/>
              </a:xfrm>
            </p:grpSpPr>
            <p:sp>
              <p:nvSpPr>
                <p:cNvPr id="46" name="テキスト ボックス 45"/>
                <p:cNvSpPr txBox="1"/>
                <p:nvPr/>
              </p:nvSpPr>
              <p:spPr>
                <a:xfrm rot="16200000">
                  <a:off x="249851" y="1899509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47" name="テキスト ボックス 46"/>
                <p:cNvSpPr txBox="1"/>
                <p:nvPr/>
              </p:nvSpPr>
              <p:spPr>
                <a:xfrm>
                  <a:off x="951851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14" name="図 13"/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730400" y="9648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18" name="図形グループ 17"/>
          <p:cNvGrpSpPr/>
          <p:nvPr/>
        </p:nvGrpSpPr>
        <p:grpSpPr>
          <a:xfrm>
            <a:off x="2343600" y="3529243"/>
            <a:ext cx="2077199" cy="3232094"/>
            <a:chOff x="2343600" y="3529243"/>
            <a:chExt cx="2077199" cy="3232094"/>
          </a:xfrm>
        </p:grpSpPr>
        <p:grpSp>
          <p:nvGrpSpPr>
            <p:cNvPr id="75" name="図形グループ 74"/>
            <p:cNvGrpSpPr/>
            <p:nvPr/>
          </p:nvGrpSpPr>
          <p:grpSpPr>
            <a:xfrm>
              <a:off x="2343600" y="3529243"/>
              <a:ext cx="2077199" cy="3232094"/>
              <a:chOff x="269819" y="114290"/>
              <a:chExt cx="2077199" cy="3232094"/>
            </a:xfrm>
          </p:grpSpPr>
          <p:sp>
            <p:nvSpPr>
              <p:cNvPr id="76" name="テキスト ボックス 75"/>
              <p:cNvSpPr txBox="1"/>
              <p:nvPr/>
            </p:nvSpPr>
            <p:spPr>
              <a:xfrm>
                <a:off x="269819" y="114290"/>
                <a:ext cx="1965455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6) Second-generation </a:t>
                </a:r>
              </a:p>
              <a:p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cephalosporin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J01DC) 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77" name="テキスト ボックス 76"/>
              <p:cNvSpPr txBox="1"/>
              <p:nvPr/>
            </p:nvSpPr>
            <p:spPr>
              <a:xfrm>
                <a:off x="269819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3.0 (1.0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5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.8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06 (0.85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30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78" name="図形グループ 77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79" name="テキスト ボックス 78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80" name="テキスト ボックス 79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17" name="図 16"/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70400" y="44424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20" name="図形グループ 19"/>
          <p:cNvGrpSpPr/>
          <p:nvPr/>
        </p:nvGrpSpPr>
        <p:grpSpPr>
          <a:xfrm>
            <a:off x="4503600" y="3529243"/>
            <a:ext cx="2077199" cy="3232094"/>
            <a:chOff x="4503600" y="3529243"/>
            <a:chExt cx="2077199" cy="3232094"/>
          </a:xfrm>
        </p:grpSpPr>
        <p:grpSp>
          <p:nvGrpSpPr>
            <p:cNvPr id="85" name="図形グループ 84"/>
            <p:cNvGrpSpPr/>
            <p:nvPr/>
          </p:nvGrpSpPr>
          <p:grpSpPr>
            <a:xfrm>
              <a:off x="4503600" y="3529243"/>
              <a:ext cx="2077199" cy="3232094"/>
              <a:chOff x="269819" y="114290"/>
              <a:chExt cx="2077199" cy="3232094"/>
            </a:xfrm>
          </p:grpSpPr>
          <p:sp>
            <p:nvSpPr>
              <p:cNvPr id="87" name="テキスト ボックス 86"/>
              <p:cNvSpPr txBox="1"/>
              <p:nvPr/>
            </p:nvSpPr>
            <p:spPr>
              <a:xfrm>
                <a:off x="269819" y="114290"/>
                <a:ext cx="2017659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7) Third-generation </a:t>
                </a:r>
              </a:p>
              <a:p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cephalosporin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J01DD) (</a:t>
                </a:r>
                <a:r>
                  <a:rPr kumimoji="1" lang="en-US" altLang="ja-JP" sz="1050" b="1" dirty="0" err="1">
                    <a:latin typeface="Helvetica"/>
                    <a:ea typeface="メイリオ"/>
                    <a:cs typeface="Helvetica"/>
                  </a:rPr>
                  <a:t>po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88" name="テキスト ボックス 87"/>
              <p:cNvSpPr txBox="1"/>
              <p:nvPr/>
            </p:nvSpPr>
            <p:spPr>
              <a:xfrm>
                <a:off x="269819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3.0 (1.0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7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90 (0.77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05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89" name="図形グループ 88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90" name="テキスト ボックス 89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91" name="テキスト ボックス 90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19" name="図 18"/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730400" y="44424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22" name="図形グループ 21"/>
          <p:cNvGrpSpPr/>
          <p:nvPr/>
        </p:nvGrpSpPr>
        <p:grpSpPr>
          <a:xfrm>
            <a:off x="6663600" y="3529243"/>
            <a:ext cx="2077199" cy="3232094"/>
            <a:chOff x="6663600" y="3529243"/>
            <a:chExt cx="2077199" cy="3232094"/>
          </a:xfrm>
        </p:grpSpPr>
        <p:grpSp>
          <p:nvGrpSpPr>
            <p:cNvPr id="95" name="図形グループ 94"/>
            <p:cNvGrpSpPr/>
            <p:nvPr/>
          </p:nvGrpSpPr>
          <p:grpSpPr>
            <a:xfrm>
              <a:off x="6663600" y="3529243"/>
              <a:ext cx="2077199" cy="3232094"/>
              <a:chOff x="269819" y="114290"/>
              <a:chExt cx="2077199" cy="3232094"/>
            </a:xfrm>
          </p:grpSpPr>
          <p:sp>
            <p:nvSpPr>
              <p:cNvPr id="97" name="テキスト ボックス 96"/>
              <p:cNvSpPr txBox="1"/>
              <p:nvPr/>
            </p:nvSpPr>
            <p:spPr>
              <a:xfrm>
                <a:off x="269819" y="114290"/>
                <a:ext cx="1965455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8) Third-generation </a:t>
                </a:r>
              </a:p>
              <a:p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cephalosporin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J01DD) 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98" name="テキスト ボックス 97"/>
              <p:cNvSpPr txBox="1"/>
              <p:nvPr/>
            </p:nvSpPr>
            <p:spPr>
              <a:xfrm>
                <a:off x="269819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4.0 (2.0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7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02 (0.89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15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99" name="図形グループ 98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100" name="テキスト ボックス 99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101" name="テキスト ボックス 100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21" name="図 20"/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890400" y="4442400"/>
              <a:ext cx="1440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315531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図形グループ 11"/>
          <p:cNvGrpSpPr/>
          <p:nvPr/>
        </p:nvGrpSpPr>
        <p:grpSpPr>
          <a:xfrm>
            <a:off x="4503600" y="50400"/>
            <a:ext cx="2238745" cy="3232094"/>
            <a:chOff x="185141" y="3529243"/>
            <a:chExt cx="2238745" cy="3232094"/>
          </a:xfrm>
        </p:grpSpPr>
        <p:grpSp>
          <p:nvGrpSpPr>
            <p:cNvPr id="67" name="図形グループ 66"/>
            <p:cNvGrpSpPr/>
            <p:nvPr/>
          </p:nvGrpSpPr>
          <p:grpSpPr>
            <a:xfrm>
              <a:off x="185141" y="3529243"/>
              <a:ext cx="2238745" cy="3232094"/>
              <a:chOff x="269819" y="114290"/>
              <a:chExt cx="2238745" cy="3232094"/>
            </a:xfrm>
          </p:grpSpPr>
          <p:sp>
            <p:nvSpPr>
              <p:cNvPr id="68" name="テキスト ボックス 67"/>
              <p:cNvSpPr txBox="1"/>
              <p:nvPr/>
            </p:nvSpPr>
            <p:spPr>
              <a:xfrm>
                <a:off x="269819" y="114290"/>
                <a:ext cx="2238745" cy="577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1) Combinations of sulfonamides and trimethoprim, incl. derivatives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J01EE) (</a:t>
                </a:r>
                <a:r>
                  <a:rPr kumimoji="1" lang="en-US" altLang="ja-JP" sz="1050" b="1" dirty="0" err="1">
                    <a:latin typeface="Helvetica"/>
                    <a:ea typeface="メイリオ"/>
                    <a:cs typeface="Helvetica"/>
                  </a:rPr>
                  <a:t>po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69" name="テキスト ボックス 68"/>
              <p:cNvSpPr txBox="1"/>
              <p:nvPr/>
            </p:nvSpPr>
            <p:spPr>
              <a:xfrm>
                <a:off x="269819" y="658053"/>
                <a:ext cx="21413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8.5 (4.0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21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89 (0.77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01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70" name="図形グループ 69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72" name="テキスト ボックス 71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73" name="テキスト ボックス 72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86" name="図 8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1941" y="4443643"/>
              <a:ext cx="1440000" cy="2160000"/>
            </a:xfrm>
            <a:prstGeom prst="rect">
              <a:avLst/>
            </a:prstGeom>
          </p:spPr>
        </p:pic>
      </p:grpSp>
      <p:grpSp>
        <p:nvGrpSpPr>
          <p:cNvPr id="2" name="図形グループ 1"/>
          <p:cNvGrpSpPr/>
          <p:nvPr/>
        </p:nvGrpSpPr>
        <p:grpSpPr>
          <a:xfrm>
            <a:off x="183600" y="3529243"/>
            <a:ext cx="2132878" cy="3232094"/>
            <a:chOff x="6668408" y="3529243"/>
            <a:chExt cx="2132878" cy="3232094"/>
          </a:xfrm>
        </p:grpSpPr>
        <p:grpSp>
          <p:nvGrpSpPr>
            <p:cNvPr id="95" name="図形グループ 94"/>
            <p:cNvGrpSpPr/>
            <p:nvPr/>
          </p:nvGrpSpPr>
          <p:grpSpPr>
            <a:xfrm>
              <a:off x="6668408" y="3529243"/>
              <a:ext cx="2132878" cy="3232094"/>
              <a:chOff x="269819" y="114290"/>
              <a:chExt cx="2132878" cy="3232094"/>
            </a:xfrm>
          </p:grpSpPr>
          <p:sp>
            <p:nvSpPr>
              <p:cNvPr id="97" name="テキスト ボックス 96"/>
              <p:cNvSpPr txBox="1"/>
              <p:nvPr/>
            </p:nvSpPr>
            <p:spPr>
              <a:xfrm>
                <a:off x="269819" y="114290"/>
                <a:ext cx="1918580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3) Other aminoglycosides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(J01GB) (iv) </a:t>
                </a:r>
                <a:endParaRPr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98" name="テキスト ボックス 97"/>
              <p:cNvSpPr txBox="1"/>
              <p:nvPr/>
            </p:nvSpPr>
            <p:spPr>
              <a:xfrm>
                <a:off x="269819" y="658053"/>
                <a:ext cx="21328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7.0 (3.0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11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27 (1.12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43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99" name="図形グループ 98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100" name="テキスト ボックス 99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101" name="テキスト ボックス 100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96" name="図 9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95208" y="44424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51" name="図形グループ 50"/>
          <p:cNvGrpSpPr/>
          <p:nvPr/>
        </p:nvGrpSpPr>
        <p:grpSpPr>
          <a:xfrm>
            <a:off x="2343600" y="3528000"/>
            <a:ext cx="2205896" cy="3232094"/>
            <a:chOff x="185141" y="50781"/>
            <a:chExt cx="2205896" cy="3232094"/>
          </a:xfrm>
        </p:grpSpPr>
        <p:grpSp>
          <p:nvGrpSpPr>
            <p:cNvPr id="52" name="図形グループ 51"/>
            <p:cNvGrpSpPr/>
            <p:nvPr/>
          </p:nvGrpSpPr>
          <p:grpSpPr>
            <a:xfrm>
              <a:off x="185141" y="50781"/>
              <a:ext cx="2205896" cy="3232094"/>
              <a:chOff x="269819" y="114290"/>
              <a:chExt cx="2205896" cy="3232094"/>
            </a:xfrm>
          </p:grpSpPr>
          <p:sp>
            <p:nvSpPr>
              <p:cNvPr id="54" name="テキスト ボックス 53"/>
              <p:cNvSpPr txBox="1"/>
              <p:nvPr/>
            </p:nvSpPr>
            <p:spPr>
              <a:xfrm>
                <a:off x="269819" y="114290"/>
                <a:ext cx="2205896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4)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Fluoroquinolone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(J01MA) </a:t>
                </a:r>
              </a:p>
              <a:p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</a:t>
                </a:r>
                <a:r>
                  <a:rPr kumimoji="1" lang="en-US" altLang="ja-JP" sz="1050" b="1" dirty="0" err="1">
                    <a:latin typeface="Helvetica"/>
                    <a:ea typeface="メイリオ"/>
                    <a:cs typeface="Helvetica"/>
                  </a:rPr>
                  <a:t>po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55" name="テキスト ボックス 54"/>
              <p:cNvSpPr txBox="1"/>
              <p:nvPr/>
            </p:nvSpPr>
            <p:spPr>
              <a:xfrm>
                <a:off x="269819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4.0 (2.0–8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92 (0.83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01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56" name="図形グループ 55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57" name="テキスト ボックス 56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59" name="テキスト ボックス 58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53" name="図 5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1941" y="963876"/>
              <a:ext cx="1440000" cy="2160000"/>
            </a:xfrm>
            <a:prstGeom prst="rect">
              <a:avLst/>
            </a:prstGeom>
          </p:spPr>
        </p:pic>
      </p:grpSp>
      <p:grpSp>
        <p:nvGrpSpPr>
          <p:cNvPr id="91" name="図形グループ 90"/>
          <p:cNvGrpSpPr/>
          <p:nvPr/>
        </p:nvGrpSpPr>
        <p:grpSpPr>
          <a:xfrm>
            <a:off x="6663600" y="3528000"/>
            <a:ext cx="2192149" cy="3232094"/>
            <a:chOff x="4430251" y="50781"/>
            <a:chExt cx="2192149" cy="3232094"/>
          </a:xfrm>
        </p:grpSpPr>
        <p:grpSp>
          <p:nvGrpSpPr>
            <p:cNvPr id="92" name="図形グループ 91"/>
            <p:cNvGrpSpPr/>
            <p:nvPr/>
          </p:nvGrpSpPr>
          <p:grpSpPr>
            <a:xfrm>
              <a:off x="4430251" y="50781"/>
              <a:ext cx="2192149" cy="3232094"/>
              <a:chOff x="265686" y="114290"/>
              <a:chExt cx="2192149" cy="3232094"/>
            </a:xfrm>
          </p:grpSpPr>
          <p:sp>
            <p:nvSpPr>
              <p:cNvPr id="102" name="テキスト ボックス 101"/>
              <p:cNvSpPr txBox="1"/>
              <p:nvPr/>
            </p:nvSpPr>
            <p:spPr>
              <a:xfrm>
                <a:off x="269819" y="114290"/>
                <a:ext cx="2188016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6)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Glycopeptide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antibacterials</a:t>
                </a:r>
                <a:endParaRPr lang="en-US" altLang="ja-JP" sz="1050" b="1" dirty="0">
                  <a:latin typeface="Helvetica"/>
                  <a:ea typeface="メイリオ"/>
                  <a:cs typeface="Helvetica"/>
                </a:endParaRP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(J01XA)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 (</a:t>
                </a:r>
                <a:r>
                  <a:rPr kumimoji="1" lang="en-US" altLang="ja-JP" sz="1050" b="1" dirty="0" err="1">
                    <a:latin typeface="Helvetica"/>
                    <a:ea typeface="メイリオ"/>
                    <a:cs typeface="Helvetica"/>
                  </a:rPr>
                  <a:t>po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103" name="テキスト ボックス 102"/>
              <p:cNvSpPr txBox="1"/>
              <p:nvPr/>
            </p:nvSpPr>
            <p:spPr>
              <a:xfrm>
                <a:off x="265686" y="658053"/>
                <a:ext cx="21413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7.0 (2.0–10.3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79 (0.47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18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104" name="図形グループ 103"/>
              <p:cNvGrpSpPr/>
              <p:nvPr/>
            </p:nvGrpSpPr>
            <p:grpSpPr>
              <a:xfrm>
                <a:off x="287518" y="1824058"/>
                <a:ext cx="1204221" cy="1522326"/>
                <a:chOff x="325683" y="1824058"/>
                <a:chExt cx="1204221" cy="1522326"/>
              </a:xfrm>
            </p:grpSpPr>
            <p:sp>
              <p:nvSpPr>
                <p:cNvPr id="105" name="テキスト ボックス 104"/>
                <p:cNvSpPr txBox="1"/>
                <p:nvPr/>
              </p:nvSpPr>
              <p:spPr>
                <a:xfrm rot="16200000">
                  <a:off x="249851" y="1899890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106" name="テキスト ボックス 105"/>
                <p:cNvSpPr txBox="1"/>
                <p:nvPr/>
              </p:nvSpPr>
              <p:spPr>
                <a:xfrm>
                  <a:off x="951851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93" name="図 9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57051" y="963876"/>
              <a:ext cx="1440000" cy="2160000"/>
            </a:xfrm>
            <a:prstGeom prst="rect">
              <a:avLst/>
            </a:prstGeom>
          </p:spPr>
        </p:pic>
      </p:grpSp>
      <p:grpSp>
        <p:nvGrpSpPr>
          <p:cNvPr id="5" name="図形グループ 4"/>
          <p:cNvGrpSpPr/>
          <p:nvPr/>
        </p:nvGrpSpPr>
        <p:grpSpPr>
          <a:xfrm>
            <a:off x="183600" y="50781"/>
            <a:ext cx="2132878" cy="3232094"/>
            <a:chOff x="183600" y="50781"/>
            <a:chExt cx="2132878" cy="3232094"/>
          </a:xfrm>
        </p:grpSpPr>
        <p:grpSp>
          <p:nvGrpSpPr>
            <p:cNvPr id="32" name="図形グループ 31"/>
            <p:cNvGrpSpPr/>
            <p:nvPr/>
          </p:nvGrpSpPr>
          <p:grpSpPr>
            <a:xfrm>
              <a:off x="183600" y="50781"/>
              <a:ext cx="2132878" cy="3232094"/>
              <a:chOff x="267001" y="114290"/>
              <a:chExt cx="2132878" cy="3232094"/>
            </a:xfrm>
          </p:grpSpPr>
          <p:sp>
            <p:nvSpPr>
              <p:cNvPr id="33" name="テキスト ボックス 32"/>
              <p:cNvSpPr txBox="1"/>
              <p:nvPr/>
            </p:nvSpPr>
            <p:spPr>
              <a:xfrm>
                <a:off x="269819" y="114290"/>
                <a:ext cx="1958026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9)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 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Fourth-generation </a:t>
                </a:r>
              </a:p>
              <a:p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cephalosporin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(J01DE) (iv) </a:t>
                </a:r>
                <a:endParaRPr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267001" y="658053"/>
                <a:ext cx="21328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5.0 (2.0–11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19 (0.999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40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35" name="図形グループ 34"/>
              <p:cNvGrpSpPr/>
              <p:nvPr/>
            </p:nvGrpSpPr>
            <p:grpSpPr>
              <a:xfrm>
                <a:off x="288833" y="1823677"/>
                <a:ext cx="1204221" cy="1522707"/>
                <a:chOff x="326998" y="1823677"/>
                <a:chExt cx="1204221" cy="1522707"/>
              </a:xfrm>
            </p:grpSpPr>
            <p:sp>
              <p:nvSpPr>
                <p:cNvPr id="37" name="テキスト ボックス 36"/>
                <p:cNvSpPr txBox="1"/>
                <p:nvPr/>
              </p:nvSpPr>
              <p:spPr>
                <a:xfrm rot="16200000">
                  <a:off x="251166" y="1899509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38" name="テキスト ボックス 37"/>
                <p:cNvSpPr txBox="1"/>
                <p:nvPr/>
              </p:nvSpPr>
              <p:spPr>
                <a:xfrm>
                  <a:off x="953166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4" name="図 3"/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0400" y="9648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7" name="図形グループ 6"/>
          <p:cNvGrpSpPr/>
          <p:nvPr/>
        </p:nvGrpSpPr>
        <p:grpSpPr>
          <a:xfrm>
            <a:off x="2343600" y="50781"/>
            <a:ext cx="2109832" cy="3232094"/>
            <a:chOff x="2343600" y="50781"/>
            <a:chExt cx="2109832" cy="3232094"/>
          </a:xfrm>
        </p:grpSpPr>
        <p:grpSp>
          <p:nvGrpSpPr>
            <p:cNvPr id="58" name="図形グループ 57"/>
            <p:cNvGrpSpPr/>
            <p:nvPr/>
          </p:nvGrpSpPr>
          <p:grpSpPr>
            <a:xfrm>
              <a:off x="2343600" y="50781"/>
              <a:ext cx="2109832" cy="3232094"/>
              <a:chOff x="265686" y="114290"/>
              <a:chExt cx="2109832" cy="3232094"/>
            </a:xfrm>
          </p:grpSpPr>
          <p:sp>
            <p:nvSpPr>
              <p:cNvPr id="60" name="テキスト ボックス 59"/>
              <p:cNvSpPr txBox="1"/>
              <p:nvPr/>
            </p:nvSpPr>
            <p:spPr>
              <a:xfrm>
                <a:off x="269819" y="114290"/>
                <a:ext cx="210569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0)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Carbapenem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(J01DH) (iv) </a:t>
                </a:r>
                <a:endParaRPr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265686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5.0 (2.0–9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03 (0.92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14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62" name="図形グループ 61"/>
              <p:cNvGrpSpPr/>
              <p:nvPr/>
            </p:nvGrpSpPr>
            <p:grpSpPr>
              <a:xfrm>
                <a:off x="287518" y="1823677"/>
                <a:ext cx="1204221" cy="1522707"/>
                <a:chOff x="325683" y="1823677"/>
                <a:chExt cx="1204221" cy="1522707"/>
              </a:xfrm>
            </p:grpSpPr>
            <p:sp>
              <p:nvSpPr>
                <p:cNvPr id="63" name="テキスト ボックス 62"/>
                <p:cNvSpPr txBox="1"/>
                <p:nvPr/>
              </p:nvSpPr>
              <p:spPr>
                <a:xfrm rot="16200000">
                  <a:off x="249851" y="1899509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64" name="テキスト ボックス 63"/>
                <p:cNvSpPr txBox="1"/>
                <p:nvPr/>
              </p:nvSpPr>
              <p:spPr>
                <a:xfrm>
                  <a:off x="951851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6" name="図 5"/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70400" y="9648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9" name="図形グループ 8"/>
          <p:cNvGrpSpPr/>
          <p:nvPr/>
        </p:nvGrpSpPr>
        <p:grpSpPr>
          <a:xfrm>
            <a:off x="6663600" y="50400"/>
            <a:ext cx="2234628" cy="3232094"/>
            <a:chOff x="6663600" y="50400"/>
            <a:chExt cx="2234628" cy="3232094"/>
          </a:xfrm>
        </p:grpSpPr>
        <p:grpSp>
          <p:nvGrpSpPr>
            <p:cNvPr id="75" name="図形グループ 74"/>
            <p:cNvGrpSpPr/>
            <p:nvPr/>
          </p:nvGrpSpPr>
          <p:grpSpPr>
            <a:xfrm>
              <a:off x="6663600" y="50400"/>
              <a:ext cx="2234628" cy="3232094"/>
              <a:chOff x="269819" y="114290"/>
              <a:chExt cx="2234628" cy="3232094"/>
            </a:xfrm>
          </p:grpSpPr>
          <p:sp>
            <p:nvSpPr>
              <p:cNvPr id="76" name="テキスト ボックス 75"/>
              <p:cNvSpPr txBox="1"/>
              <p:nvPr/>
            </p:nvSpPr>
            <p:spPr>
              <a:xfrm>
                <a:off x="269819" y="114290"/>
                <a:ext cx="2234628" cy="5770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2) Combinations of 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sulfonamides and trimethoprim, 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incl. derivatives (J01EE) 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77" name="テキスト ボックス 76"/>
              <p:cNvSpPr txBox="1"/>
              <p:nvPr/>
            </p:nvSpPr>
            <p:spPr>
              <a:xfrm>
                <a:off x="269819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3.0 (1.8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4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75 (1.12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2.48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78" name="図形グループ 77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79" name="テキスト ボックス 78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80" name="テキスト ボックス 79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8" name="図 7"/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890400" y="9648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14" name="図形グループ 13"/>
          <p:cNvGrpSpPr/>
          <p:nvPr/>
        </p:nvGrpSpPr>
        <p:grpSpPr>
          <a:xfrm>
            <a:off x="4503600" y="3528000"/>
            <a:ext cx="2208714" cy="3232094"/>
            <a:chOff x="4503600" y="3528000"/>
            <a:chExt cx="2208714" cy="3232094"/>
          </a:xfrm>
        </p:grpSpPr>
        <p:grpSp>
          <p:nvGrpSpPr>
            <p:cNvPr id="66" name="図形グループ 65"/>
            <p:cNvGrpSpPr/>
            <p:nvPr/>
          </p:nvGrpSpPr>
          <p:grpSpPr>
            <a:xfrm>
              <a:off x="4503600" y="3528000"/>
              <a:ext cx="2208714" cy="3232094"/>
              <a:chOff x="267001" y="114290"/>
              <a:chExt cx="2208714" cy="3232094"/>
            </a:xfrm>
          </p:grpSpPr>
          <p:sp>
            <p:nvSpPr>
              <p:cNvPr id="81" name="テキスト ボックス 80"/>
              <p:cNvSpPr txBox="1"/>
              <p:nvPr/>
            </p:nvSpPr>
            <p:spPr>
              <a:xfrm>
                <a:off x="269819" y="114290"/>
                <a:ext cx="2205896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5)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Fluoroquinolone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(J01MA) </a:t>
                </a:r>
              </a:p>
              <a:p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82" name="テキスト ボックス 81"/>
              <p:cNvSpPr txBox="1"/>
              <p:nvPr/>
            </p:nvSpPr>
            <p:spPr>
              <a:xfrm>
                <a:off x="267001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4.0 (2.0–7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14 (0.97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33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83" name="図形グループ 82"/>
              <p:cNvGrpSpPr/>
              <p:nvPr/>
            </p:nvGrpSpPr>
            <p:grpSpPr>
              <a:xfrm>
                <a:off x="288833" y="1824058"/>
                <a:ext cx="1204221" cy="1522326"/>
                <a:chOff x="326998" y="1824058"/>
                <a:chExt cx="1204221" cy="1522326"/>
              </a:xfrm>
            </p:grpSpPr>
            <p:sp>
              <p:nvSpPr>
                <p:cNvPr id="89" name="テキスト ボックス 88"/>
                <p:cNvSpPr txBox="1"/>
                <p:nvPr/>
              </p:nvSpPr>
              <p:spPr>
                <a:xfrm rot="16200000">
                  <a:off x="251166" y="1899890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90" name="テキスト ボックス 89"/>
                <p:cNvSpPr txBox="1"/>
                <p:nvPr/>
              </p:nvSpPr>
              <p:spPr>
                <a:xfrm>
                  <a:off x="953166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10" name="図 9"/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730400" y="4442400"/>
              <a:ext cx="1440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850273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図形グループ 5"/>
          <p:cNvGrpSpPr/>
          <p:nvPr/>
        </p:nvGrpSpPr>
        <p:grpSpPr>
          <a:xfrm>
            <a:off x="183600" y="50781"/>
            <a:ext cx="2254212" cy="3232094"/>
            <a:chOff x="6668408" y="50781"/>
            <a:chExt cx="2254212" cy="3232094"/>
          </a:xfrm>
        </p:grpSpPr>
        <p:grpSp>
          <p:nvGrpSpPr>
            <p:cNvPr id="58" name="図形グループ 57"/>
            <p:cNvGrpSpPr/>
            <p:nvPr/>
          </p:nvGrpSpPr>
          <p:grpSpPr>
            <a:xfrm>
              <a:off x="6668408" y="50781"/>
              <a:ext cx="2254212" cy="3232094"/>
              <a:chOff x="265686" y="114290"/>
              <a:chExt cx="2254212" cy="3232094"/>
            </a:xfrm>
          </p:grpSpPr>
          <p:sp>
            <p:nvSpPr>
              <p:cNvPr id="60" name="テキスト ボックス 59"/>
              <p:cNvSpPr txBox="1"/>
              <p:nvPr/>
            </p:nvSpPr>
            <p:spPr>
              <a:xfrm>
                <a:off x="269819" y="114290"/>
                <a:ext cx="2250079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7)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Glycopeptide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antibacterials</a:t>
                </a:r>
                <a:endParaRPr lang="en-US" altLang="ja-JP" sz="1050" b="1" dirty="0">
                  <a:latin typeface="Helvetica"/>
                  <a:ea typeface="メイリオ"/>
                  <a:cs typeface="Helvetica"/>
                </a:endParaRP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(J01XA)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265686" y="658053"/>
                <a:ext cx="21413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5.0 (2.0–10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10 (1.01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18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62" name="図形グループ 61"/>
              <p:cNvGrpSpPr/>
              <p:nvPr/>
            </p:nvGrpSpPr>
            <p:grpSpPr>
              <a:xfrm>
                <a:off x="287518" y="1823677"/>
                <a:ext cx="1204221" cy="1522707"/>
                <a:chOff x="325683" y="1823677"/>
                <a:chExt cx="1204221" cy="1522707"/>
              </a:xfrm>
            </p:grpSpPr>
            <p:sp>
              <p:nvSpPr>
                <p:cNvPr id="63" name="テキスト ボックス 62"/>
                <p:cNvSpPr txBox="1"/>
                <p:nvPr/>
              </p:nvSpPr>
              <p:spPr>
                <a:xfrm rot="16200000">
                  <a:off x="249851" y="1899509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64" name="テキスト ボックス 63"/>
                <p:cNvSpPr txBox="1"/>
                <p:nvPr/>
              </p:nvSpPr>
              <p:spPr>
                <a:xfrm>
                  <a:off x="951851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96" name="図 9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895208" y="963876"/>
              <a:ext cx="1440000" cy="2160000"/>
            </a:xfrm>
            <a:prstGeom prst="rect">
              <a:avLst/>
            </a:prstGeom>
          </p:spPr>
        </p:pic>
      </p:grpSp>
      <p:grpSp>
        <p:nvGrpSpPr>
          <p:cNvPr id="13" name="図形グループ 12"/>
          <p:cNvGrpSpPr/>
          <p:nvPr/>
        </p:nvGrpSpPr>
        <p:grpSpPr>
          <a:xfrm>
            <a:off x="4503600" y="50400"/>
            <a:ext cx="2205577" cy="3232094"/>
            <a:chOff x="4455858" y="3529243"/>
            <a:chExt cx="2205577" cy="3232094"/>
          </a:xfrm>
        </p:grpSpPr>
        <p:grpSp>
          <p:nvGrpSpPr>
            <p:cNvPr id="85" name="図形グループ 84"/>
            <p:cNvGrpSpPr/>
            <p:nvPr/>
          </p:nvGrpSpPr>
          <p:grpSpPr>
            <a:xfrm>
              <a:off x="4455858" y="3529243"/>
              <a:ext cx="2205577" cy="3232094"/>
              <a:chOff x="269819" y="114290"/>
              <a:chExt cx="2205577" cy="3232094"/>
            </a:xfrm>
          </p:grpSpPr>
          <p:sp>
            <p:nvSpPr>
              <p:cNvPr id="87" name="テキスト ボックス 86"/>
              <p:cNvSpPr txBox="1"/>
              <p:nvPr/>
            </p:nvSpPr>
            <p:spPr>
              <a:xfrm>
                <a:off x="269819" y="114290"/>
                <a:ext cx="1694181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9) Other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antibacterials</a:t>
                </a:r>
                <a:endParaRPr lang="en-US" altLang="ja-JP" sz="1050" b="1" dirty="0">
                  <a:latin typeface="Helvetica"/>
                  <a:ea typeface="メイリオ"/>
                  <a:cs typeface="Helvetica"/>
                </a:endParaRPr>
              </a:p>
              <a:p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J01XX) (</a:t>
                </a:r>
                <a:r>
                  <a:rPr kumimoji="1" lang="en-US" altLang="ja-JP" sz="1050" b="1" dirty="0" err="1">
                    <a:latin typeface="Helvetica"/>
                    <a:ea typeface="メイリオ"/>
                    <a:cs typeface="Helvetica"/>
                  </a:rPr>
                  <a:t>po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88" name="テキスト ボックス 87"/>
              <p:cNvSpPr txBox="1"/>
              <p:nvPr/>
            </p:nvSpPr>
            <p:spPr>
              <a:xfrm>
                <a:off x="269819" y="658053"/>
                <a:ext cx="22055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10.0 (5.5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12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2.07 (1.13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3.27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89" name="図形グループ 88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90" name="テキスト ボックス 89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91" name="テキスト ボックス 90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104" name="図 10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82658" y="4443643"/>
              <a:ext cx="1440000" cy="2160000"/>
            </a:xfrm>
            <a:prstGeom prst="rect">
              <a:avLst/>
            </a:prstGeom>
          </p:spPr>
        </p:pic>
      </p:grpSp>
      <p:grpSp>
        <p:nvGrpSpPr>
          <p:cNvPr id="65" name="図形グループ 64"/>
          <p:cNvGrpSpPr/>
          <p:nvPr/>
        </p:nvGrpSpPr>
        <p:grpSpPr>
          <a:xfrm>
            <a:off x="183600" y="3528000"/>
            <a:ext cx="2077199" cy="3232094"/>
            <a:chOff x="2344879" y="50781"/>
            <a:chExt cx="2077199" cy="3232094"/>
          </a:xfrm>
        </p:grpSpPr>
        <p:grpSp>
          <p:nvGrpSpPr>
            <p:cNvPr id="66" name="図形グループ 65"/>
            <p:cNvGrpSpPr/>
            <p:nvPr/>
          </p:nvGrpSpPr>
          <p:grpSpPr>
            <a:xfrm>
              <a:off x="2344879" y="50781"/>
              <a:ext cx="2077199" cy="3232094"/>
              <a:chOff x="267001" y="114290"/>
              <a:chExt cx="2077199" cy="3232094"/>
            </a:xfrm>
          </p:grpSpPr>
          <p:sp>
            <p:nvSpPr>
              <p:cNvPr id="71" name="テキスト ボックス 70"/>
              <p:cNvSpPr txBox="1"/>
              <p:nvPr/>
            </p:nvSpPr>
            <p:spPr>
              <a:xfrm>
                <a:off x="269819" y="114290"/>
                <a:ext cx="189306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21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Antibiotics (J02AA)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 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72" name="テキスト ボックス 71"/>
              <p:cNvSpPr txBox="1"/>
              <p:nvPr/>
            </p:nvSpPr>
            <p:spPr>
              <a:xfrm>
                <a:off x="267001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5.0 (2.0–9.3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94 (0.83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05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73" name="図形グループ 72"/>
              <p:cNvGrpSpPr/>
              <p:nvPr/>
            </p:nvGrpSpPr>
            <p:grpSpPr>
              <a:xfrm>
                <a:off x="288833" y="1824058"/>
                <a:ext cx="1204221" cy="1522326"/>
                <a:chOff x="326998" y="1824058"/>
                <a:chExt cx="1204221" cy="1522326"/>
              </a:xfrm>
            </p:grpSpPr>
            <p:sp>
              <p:nvSpPr>
                <p:cNvPr id="74" name="テキスト ボックス 73"/>
                <p:cNvSpPr txBox="1"/>
                <p:nvPr/>
              </p:nvSpPr>
              <p:spPr>
                <a:xfrm rot="16200000">
                  <a:off x="251166" y="1899890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81" name="テキスト ボックス 80"/>
                <p:cNvSpPr txBox="1"/>
                <p:nvPr/>
              </p:nvSpPr>
              <p:spPr>
                <a:xfrm>
                  <a:off x="953166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70" name="図 6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70503" y="963876"/>
              <a:ext cx="1440000" cy="2160000"/>
            </a:xfrm>
            <a:prstGeom prst="rect">
              <a:avLst/>
            </a:prstGeom>
          </p:spPr>
        </p:pic>
      </p:grpSp>
      <p:grpSp>
        <p:nvGrpSpPr>
          <p:cNvPr id="82" name="図形グループ 81"/>
          <p:cNvGrpSpPr/>
          <p:nvPr/>
        </p:nvGrpSpPr>
        <p:grpSpPr>
          <a:xfrm>
            <a:off x="2343600" y="3528000"/>
            <a:ext cx="2141388" cy="3232094"/>
            <a:chOff x="4430251" y="50781"/>
            <a:chExt cx="2141388" cy="3232094"/>
          </a:xfrm>
        </p:grpSpPr>
        <p:grpSp>
          <p:nvGrpSpPr>
            <p:cNvPr id="83" name="図形グループ 82"/>
            <p:cNvGrpSpPr/>
            <p:nvPr/>
          </p:nvGrpSpPr>
          <p:grpSpPr>
            <a:xfrm>
              <a:off x="4430251" y="50781"/>
              <a:ext cx="2141388" cy="3232094"/>
              <a:chOff x="265686" y="114290"/>
              <a:chExt cx="2141388" cy="3232094"/>
            </a:xfrm>
          </p:grpSpPr>
          <p:sp>
            <p:nvSpPr>
              <p:cNvPr id="93" name="テキスト ボックス 92"/>
              <p:cNvSpPr txBox="1"/>
              <p:nvPr/>
            </p:nvSpPr>
            <p:spPr>
              <a:xfrm>
                <a:off x="269819" y="114290"/>
                <a:ext cx="1659200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22)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Triazole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derivatives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(J02AC)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 (</a:t>
                </a:r>
                <a:r>
                  <a:rPr kumimoji="1" lang="en-US" altLang="ja-JP" sz="1050" b="1" dirty="0" err="1">
                    <a:latin typeface="Helvetica"/>
                    <a:ea typeface="メイリオ"/>
                    <a:cs typeface="Helvetica"/>
                  </a:rPr>
                  <a:t>po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102" name="テキスト ボックス 101"/>
              <p:cNvSpPr txBox="1"/>
              <p:nvPr/>
            </p:nvSpPr>
            <p:spPr>
              <a:xfrm>
                <a:off x="265686" y="658053"/>
                <a:ext cx="21413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9.5 (3.0–23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94 (0.79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11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106" name="図形グループ 105"/>
              <p:cNvGrpSpPr/>
              <p:nvPr/>
            </p:nvGrpSpPr>
            <p:grpSpPr>
              <a:xfrm>
                <a:off x="287518" y="1824058"/>
                <a:ext cx="1204221" cy="1522326"/>
                <a:chOff x="325683" y="1824058"/>
                <a:chExt cx="1204221" cy="1522326"/>
              </a:xfrm>
            </p:grpSpPr>
            <p:sp>
              <p:nvSpPr>
                <p:cNvPr id="107" name="テキスト ボックス 106"/>
                <p:cNvSpPr txBox="1"/>
                <p:nvPr/>
              </p:nvSpPr>
              <p:spPr>
                <a:xfrm rot="16200000">
                  <a:off x="249851" y="1899890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108" name="テキスト ボックス 107"/>
                <p:cNvSpPr txBox="1"/>
                <p:nvPr/>
              </p:nvSpPr>
              <p:spPr>
                <a:xfrm>
                  <a:off x="951851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92" name="図 9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57051" y="963876"/>
              <a:ext cx="1440000" cy="2160000"/>
            </a:xfrm>
            <a:prstGeom prst="rect">
              <a:avLst/>
            </a:prstGeom>
          </p:spPr>
        </p:pic>
      </p:grpSp>
      <p:grpSp>
        <p:nvGrpSpPr>
          <p:cNvPr id="109" name="図形グループ 108"/>
          <p:cNvGrpSpPr/>
          <p:nvPr/>
        </p:nvGrpSpPr>
        <p:grpSpPr>
          <a:xfrm>
            <a:off x="4503600" y="3528000"/>
            <a:ext cx="2141388" cy="3232094"/>
            <a:chOff x="6668408" y="50781"/>
            <a:chExt cx="2141388" cy="3232094"/>
          </a:xfrm>
        </p:grpSpPr>
        <p:grpSp>
          <p:nvGrpSpPr>
            <p:cNvPr id="110" name="図形グループ 109"/>
            <p:cNvGrpSpPr/>
            <p:nvPr/>
          </p:nvGrpSpPr>
          <p:grpSpPr>
            <a:xfrm>
              <a:off x="6668408" y="50781"/>
              <a:ext cx="2141388" cy="3232094"/>
              <a:chOff x="265686" y="114290"/>
              <a:chExt cx="2141388" cy="3232094"/>
            </a:xfrm>
          </p:grpSpPr>
          <p:sp>
            <p:nvSpPr>
              <p:cNvPr id="112" name="テキスト ボックス 111"/>
              <p:cNvSpPr txBox="1"/>
              <p:nvPr/>
            </p:nvSpPr>
            <p:spPr>
              <a:xfrm>
                <a:off x="269819" y="114290"/>
                <a:ext cx="1659200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23)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Triazole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derivatives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(J02AC)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113" name="テキスト ボックス 112"/>
              <p:cNvSpPr txBox="1"/>
              <p:nvPr/>
            </p:nvSpPr>
            <p:spPr>
              <a:xfrm>
                <a:off x="265686" y="658053"/>
                <a:ext cx="214138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5.0 (2.0–18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83 (0.68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01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114" name="図形グループ 113"/>
              <p:cNvGrpSpPr/>
              <p:nvPr/>
            </p:nvGrpSpPr>
            <p:grpSpPr>
              <a:xfrm>
                <a:off x="287518" y="1824058"/>
                <a:ext cx="1204221" cy="1522326"/>
                <a:chOff x="325683" y="1824058"/>
                <a:chExt cx="1204221" cy="1522326"/>
              </a:xfrm>
            </p:grpSpPr>
            <p:sp>
              <p:nvSpPr>
                <p:cNvPr id="115" name="テキスト ボックス 114"/>
                <p:cNvSpPr txBox="1"/>
                <p:nvPr/>
              </p:nvSpPr>
              <p:spPr>
                <a:xfrm rot="16200000">
                  <a:off x="249851" y="1899890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116" name="テキスト ボックス 115"/>
                <p:cNvSpPr txBox="1"/>
                <p:nvPr/>
              </p:nvSpPr>
              <p:spPr>
                <a:xfrm>
                  <a:off x="951851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111" name="図 110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895208" y="963876"/>
              <a:ext cx="1440000" cy="2160000"/>
            </a:xfrm>
            <a:prstGeom prst="rect">
              <a:avLst/>
            </a:prstGeom>
          </p:spPr>
        </p:pic>
      </p:grpSp>
      <p:grpSp>
        <p:nvGrpSpPr>
          <p:cNvPr id="117" name="図形グループ 116"/>
          <p:cNvGrpSpPr/>
          <p:nvPr/>
        </p:nvGrpSpPr>
        <p:grpSpPr>
          <a:xfrm>
            <a:off x="6663600" y="3529243"/>
            <a:ext cx="2132878" cy="3232094"/>
            <a:chOff x="2347697" y="3529243"/>
            <a:chExt cx="2132878" cy="3232094"/>
          </a:xfrm>
        </p:grpSpPr>
        <p:grpSp>
          <p:nvGrpSpPr>
            <p:cNvPr id="118" name="図形グループ 117"/>
            <p:cNvGrpSpPr/>
            <p:nvPr/>
          </p:nvGrpSpPr>
          <p:grpSpPr>
            <a:xfrm>
              <a:off x="2347697" y="3529243"/>
              <a:ext cx="2132878" cy="3232094"/>
              <a:chOff x="269819" y="114290"/>
              <a:chExt cx="2132878" cy="3232094"/>
            </a:xfrm>
          </p:grpSpPr>
          <p:sp>
            <p:nvSpPr>
              <p:cNvPr id="120" name="テキスト ボックス 119"/>
              <p:cNvSpPr txBox="1"/>
              <p:nvPr/>
            </p:nvSpPr>
            <p:spPr>
              <a:xfrm>
                <a:off x="269819" y="114290"/>
                <a:ext cx="1853289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24) Other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antimycotic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for </a:t>
                </a: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systemic use (J02AX)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121" name="テキスト ボックス 120"/>
              <p:cNvSpPr txBox="1"/>
              <p:nvPr/>
            </p:nvSpPr>
            <p:spPr>
              <a:xfrm>
                <a:off x="269819" y="658053"/>
                <a:ext cx="21328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5.0 (3.0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11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96 (0.81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12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122" name="図形グループ 121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123" name="テキスト ボックス 122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124" name="テキスト ボックス 123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119" name="図 11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74497" y="44424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3" name="図形グループ 2"/>
          <p:cNvGrpSpPr/>
          <p:nvPr/>
        </p:nvGrpSpPr>
        <p:grpSpPr>
          <a:xfrm>
            <a:off x="2343600" y="50400"/>
            <a:ext cx="2077199" cy="3232094"/>
            <a:chOff x="2343600" y="50400"/>
            <a:chExt cx="2077199" cy="3232094"/>
          </a:xfrm>
        </p:grpSpPr>
        <p:grpSp>
          <p:nvGrpSpPr>
            <p:cNvPr id="75" name="図形グループ 74"/>
            <p:cNvGrpSpPr/>
            <p:nvPr/>
          </p:nvGrpSpPr>
          <p:grpSpPr>
            <a:xfrm>
              <a:off x="2343600" y="50400"/>
              <a:ext cx="2077199" cy="3232094"/>
              <a:chOff x="269819" y="114290"/>
              <a:chExt cx="2077199" cy="3232094"/>
            </a:xfrm>
          </p:grpSpPr>
          <p:sp>
            <p:nvSpPr>
              <p:cNvPr id="76" name="テキスト ボックス 75"/>
              <p:cNvSpPr txBox="1"/>
              <p:nvPr/>
            </p:nvSpPr>
            <p:spPr>
              <a:xfrm>
                <a:off x="269819" y="114290"/>
                <a:ext cx="195612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18)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Polymyxins</a:t>
                </a:r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 (J01XB)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77" name="テキスト ボックス 76"/>
              <p:cNvSpPr txBox="1"/>
              <p:nvPr/>
            </p:nvSpPr>
            <p:spPr>
              <a:xfrm>
                <a:off x="269819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3.0 (1.0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6.0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1.26 (1.05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49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78" name="図形グループ 77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79" name="テキスト ボックス 78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80" name="テキスト ボックス 79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2" name="図 1"/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570400" y="964800"/>
              <a:ext cx="1440000" cy="2160000"/>
            </a:xfrm>
            <a:prstGeom prst="rect">
              <a:avLst/>
            </a:prstGeom>
          </p:spPr>
        </p:pic>
      </p:grpSp>
      <p:grpSp>
        <p:nvGrpSpPr>
          <p:cNvPr id="5" name="図形グループ 4"/>
          <p:cNvGrpSpPr/>
          <p:nvPr/>
        </p:nvGrpSpPr>
        <p:grpSpPr>
          <a:xfrm>
            <a:off x="6663600" y="50400"/>
            <a:ext cx="2077199" cy="3232094"/>
            <a:chOff x="6663600" y="50400"/>
            <a:chExt cx="2077199" cy="3232094"/>
          </a:xfrm>
        </p:grpSpPr>
        <p:grpSp>
          <p:nvGrpSpPr>
            <p:cNvPr id="95" name="図形グループ 94"/>
            <p:cNvGrpSpPr/>
            <p:nvPr/>
          </p:nvGrpSpPr>
          <p:grpSpPr>
            <a:xfrm>
              <a:off x="6663600" y="50400"/>
              <a:ext cx="2077199" cy="3232094"/>
              <a:chOff x="269819" y="114290"/>
              <a:chExt cx="2077199" cy="3232094"/>
            </a:xfrm>
          </p:grpSpPr>
          <p:sp>
            <p:nvSpPr>
              <p:cNvPr id="97" name="テキスト ボックス 96"/>
              <p:cNvSpPr txBox="1"/>
              <p:nvPr/>
            </p:nvSpPr>
            <p:spPr>
              <a:xfrm>
                <a:off x="269819" y="114290"/>
                <a:ext cx="1681357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20) Other </a:t>
                </a:r>
                <a:r>
                  <a:rPr lang="en-US" altLang="ja-JP" sz="1050" b="1" dirty="0" err="1">
                    <a:latin typeface="Helvetica"/>
                    <a:ea typeface="メイリオ"/>
                    <a:cs typeface="Helvetica"/>
                  </a:rPr>
                  <a:t>antibacterials</a:t>
                </a:r>
                <a:endParaRPr lang="en-US" altLang="ja-JP" sz="1050" b="1" dirty="0">
                  <a:latin typeface="Helvetica"/>
                  <a:ea typeface="メイリオ"/>
                  <a:cs typeface="Helvetica"/>
                </a:endParaRPr>
              </a:p>
              <a:p>
                <a:r>
                  <a:rPr lang="en-US" altLang="ja-JP" sz="1050" b="1" dirty="0">
                    <a:latin typeface="Helvetica"/>
                    <a:ea typeface="メイリオ"/>
                    <a:cs typeface="Helvetica"/>
                  </a:rPr>
                  <a:t>(J01XX) </a:t>
                </a:r>
                <a:r>
                  <a:rPr kumimoji="1" lang="en-US" altLang="ja-JP" sz="1050" b="1" dirty="0">
                    <a:latin typeface="Helvetica"/>
                    <a:ea typeface="メイリオ"/>
                    <a:cs typeface="Helvetica"/>
                  </a:rPr>
                  <a:t>(iv) </a:t>
                </a:r>
                <a:endParaRPr kumimoji="1" lang="ja-JP" altLang="en-US" sz="1050" b="1" dirty="0">
                  <a:latin typeface="Helvetica"/>
                  <a:ea typeface="メイリオ"/>
                  <a:cs typeface="Helvetica"/>
                </a:endParaRPr>
              </a:p>
            </p:txBody>
          </p:sp>
          <p:sp>
            <p:nvSpPr>
              <p:cNvPr id="98" name="テキスト ボックス 97"/>
              <p:cNvSpPr txBox="1"/>
              <p:nvPr/>
            </p:nvSpPr>
            <p:spPr>
              <a:xfrm>
                <a:off x="269819" y="658053"/>
                <a:ext cx="20771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Median (quartiles, day): 3.0 (1.0–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7</a:t>
                </a:r>
                <a:r>
                  <a:rPr kumimoji="1" lang="en-US" altLang="ja-JP" sz="900" dirty="0">
                    <a:latin typeface="Helvetica"/>
                    <a:ea typeface="メイリオ"/>
                    <a:cs typeface="Helvetica"/>
                  </a:rPr>
                  <a:t>.0)</a:t>
                </a:r>
              </a:p>
              <a:p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β</a:t>
                </a:r>
                <a:r>
                  <a:rPr lang="en-US" altLang="en-US" sz="900" dirty="0">
                    <a:latin typeface="Helvetica"/>
                    <a:ea typeface="メイリオ"/>
                    <a:cs typeface="Helvetica"/>
                  </a:rPr>
                  <a:t> (95%CI): 0.86 (0.66</a:t>
                </a:r>
                <a:r>
                  <a:rPr lang="en-US" altLang="ja-JP" sz="900" dirty="0">
                    <a:latin typeface="Helvetica"/>
                    <a:ea typeface="メイリオ"/>
                    <a:cs typeface="Helvetica"/>
                  </a:rPr>
                  <a:t>–1.09)</a:t>
                </a:r>
                <a:endParaRPr kumimoji="1" lang="ja-JP" altLang="en-US" sz="900" dirty="0">
                  <a:latin typeface="Helvetica"/>
                  <a:ea typeface="メイリオ"/>
                  <a:cs typeface="Helvetica"/>
                </a:endParaRPr>
              </a:p>
            </p:txBody>
          </p:sp>
          <p:grpSp>
            <p:nvGrpSpPr>
              <p:cNvPr id="99" name="図形グループ 98"/>
              <p:cNvGrpSpPr/>
              <p:nvPr/>
            </p:nvGrpSpPr>
            <p:grpSpPr>
              <a:xfrm>
                <a:off x="290071" y="1824305"/>
                <a:ext cx="1204676" cy="1522079"/>
                <a:chOff x="328236" y="1824305"/>
                <a:chExt cx="1204676" cy="1522079"/>
              </a:xfrm>
            </p:grpSpPr>
            <p:sp>
              <p:nvSpPr>
                <p:cNvPr id="100" name="テキスト ボックス 99"/>
                <p:cNvSpPr txBox="1"/>
                <p:nvPr/>
              </p:nvSpPr>
              <p:spPr>
                <a:xfrm rot="16200000">
                  <a:off x="252404" y="1900137"/>
                  <a:ext cx="36710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Day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  <p:sp>
              <p:nvSpPr>
                <p:cNvPr id="101" name="テキスト ボックス 100"/>
                <p:cNvSpPr txBox="1"/>
                <p:nvPr/>
              </p:nvSpPr>
              <p:spPr>
                <a:xfrm>
                  <a:off x="954859" y="3130940"/>
                  <a:ext cx="57805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Helvetica"/>
                      <a:ea typeface="メイリオ"/>
                      <a:cs typeface="Helvetica"/>
                    </a:rPr>
                    <a:t>Case (n)</a:t>
                  </a:r>
                  <a:endParaRPr kumimoji="1" lang="ja-JP" altLang="en-US" sz="800" dirty="0">
                    <a:latin typeface="Helvetica"/>
                    <a:ea typeface="メイリオ"/>
                    <a:cs typeface="Helvetica"/>
                  </a:endParaRPr>
                </a:p>
              </p:txBody>
            </p:sp>
          </p:grpSp>
        </p:grpSp>
        <p:pic>
          <p:nvPicPr>
            <p:cNvPr id="4" name="図 3"/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890400" y="964800"/>
              <a:ext cx="1440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3759120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</TotalTime>
  <Words>856</Words>
  <Application>Microsoft Macintosh PowerPoint</Application>
  <PresentationFormat>画面に合わせる (4:3)</PresentationFormat>
  <Paragraphs>141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Helvetica</vt:lpstr>
      <vt:lpstr>ホワイト</vt:lpstr>
      <vt:lpstr>PowerPoint プレゼンテーション</vt:lpstr>
      <vt:lpstr>PowerPoint プレゼンテーション</vt:lpstr>
      <vt:lpstr>PowerPoint プレゼンテーション</vt:lpstr>
    </vt:vector>
  </TitlesOfParts>
  <Company>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 n</dc:creator>
  <cp:lastModifiedBy>n m</cp:lastModifiedBy>
  <cp:revision>125</cp:revision>
  <dcterms:created xsi:type="dcterms:W3CDTF">2019-03-12T00:45:50Z</dcterms:created>
  <dcterms:modified xsi:type="dcterms:W3CDTF">2021-08-19T10:24:48Z</dcterms:modified>
</cp:coreProperties>
</file>